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03_4AB11814.xml" ContentType="application/vnd.ms-powerpoint.comments+xml"/>
  <Override PartName="/ppt/authors.xml" ContentType="application/vnd.ms-powerpoint.author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9" r:id="rId4"/>
    <p:sldId id="256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3E28440-B29D-F8EB-0C3B-1FBD929AC480}" name="Guest User" initials="GU" userId="S::urn:spo:anon#167bea1f21bb9f2226c2cfd60bd24b6924baa1100791246c7ddde85d4ec5dd0e::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4D9E7F2-E224-3AFF-189E-DF48BE93DC4C}" v="3" dt="2022-07-06T17:58:24.4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3186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uest User" userId="S::urn:spo:anon#167bea1f21bb9f2226c2cfd60bd24b6924baa1100791246c7ddde85d4ec5dd0e::" providerId="AD" clId="Web-{14D9E7F2-E224-3AFF-189E-DF48BE93DC4C}"/>
    <pc:docChg chg="mod">
      <pc:chgData name="Guest User" userId="S::urn:spo:anon#167bea1f21bb9f2226c2cfd60bd24b6924baa1100791246c7ddde85d4ec5dd0e::" providerId="AD" clId="Web-{14D9E7F2-E224-3AFF-189E-DF48BE93DC4C}" dt="2022-07-06T17:58:24.424" v="2"/>
      <pc:docMkLst>
        <pc:docMk/>
      </pc:docMkLst>
      <pc:sldChg chg="addCm modCm">
        <pc:chgData name="Guest User" userId="S::urn:spo:anon#167bea1f21bb9f2226c2cfd60bd24b6924baa1100791246c7ddde85d4ec5dd0e::" providerId="AD" clId="Web-{14D9E7F2-E224-3AFF-189E-DF48BE93DC4C}" dt="2022-07-06T17:58:24.424" v="2"/>
        <pc:sldMkLst>
          <pc:docMk/>
          <pc:sldMk cId="1253120020" sldId="259"/>
        </pc:sldMkLst>
      </pc:sldChg>
    </pc:docChg>
  </pc:docChgLst>
</pc:chgInfo>
</file>

<file path=ppt/comments/modernComment_103_4AB11814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13053457-CB59-4B26-BBB9-85180BA50DB6}" authorId="{13E28440-B29D-F8EB-0C3B-1FBD929AC480}" created="2022-07-06T17:57:59.986">
    <pc:sldMkLst xmlns:pc="http://schemas.microsoft.com/office/powerpoint/2013/main/command">
      <pc:docMk/>
      <pc:sldMk cId="1253120020" sldId="259"/>
    </pc:sldMkLst>
    <p188:txBody>
      <a:bodyPr/>
      <a:lstStyle/>
      <a:p>
        <a:r>
          <a:rPr lang="en-US"/>
          <a:t>CDDP should be - + - + in B</a:t>
        </a:r>
      </a:p>
    </p188:txBody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111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120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591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859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386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203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828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022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289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672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962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96BD4-4086-404B-9BCA-B4B8417A6058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03999B-1B55-4743-92BB-50C23194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09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image" Target="../media/image13.jpe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microsoft.com/office/2018/10/relationships/comments" Target="../comments/modernComment_103_4AB11814.xml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75768" y="641398"/>
            <a:ext cx="2085975" cy="4406942"/>
            <a:chOff x="3475259" y="1140023"/>
            <a:chExt cx="2085975" cy="4406942"/>
          </a:xfrm>
        </p:grpSpPr>
        <p:pic>
          <p:nvPicPr>
            <p:cNvPr id="5" name="Picture 6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18" t="6782"/>
            <a:stretch/>
          </p:blipFill>
          <p:spPr bwMode="auto">
            <a:xfrm>
              <a:off x="3571587" y="1447800"/>
              <a:ext cx="1989647" cy="18912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7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75259" y="3518140"/>
              <a:ext cx="2085975" cy="2028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4210541" y="1140023"/>
              <a:ext cx="7117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P-</a:t>
              </a:r>
              <a:r>
                <a:rPr lang="en-US" sz="1000" b="1" dirty="0" err="1"/>
                <a:t>gp</a:t>
              </a:r>
              <a:endParaRPr lang="en-US" sz="100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285962" y="1948190"/>
              <a:ext cx="7117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/>
                <a:t>P=0.02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666962" y="3810000"/>
              <a:ext cx="8909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AUC: 0.57</a:t>
              </a:r>
            </a:p>
            <a:p>
              <a:r>
                <a:rPr lang="en-US" sz="1000" b="1" dirty="0"/>
                <a:t>P=0.009</a:t>
              </a: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2555052" y="661958"/>
            <a:ext cx="2032205" cy="4343164"/>
            <a:chOff x="5913658" y="1157614"/>
            <a:chExt cx="2032205" cy="4343164"/>
          </a:xfrm>
        </p:grpSpPr>
        <p:pic>
          <p:nvPicPr>
            <p:cNvPr id="11" name="Picture 8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89859" y="1447800"/>
              <a:ext cx="1925213" cy="18825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9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13658" y="3518140"/>
              <a:ext cx="2032205" cy="1982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6640895" y="1157614"/>
              <a:ext cx="7117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MRP2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640895" y="1985250"/>
              <a:ext cx="7117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/>
                <a:t>P=0.32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021895" y="3847060"/>
              <a:ext cx="8909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AUC: 0.53</a:t>
              </a:r>
            </a:p>
            <a:p>
              <a:r>
                <a:rPr lang="en-US" sz="1000" b="1" dirty="0"/>
                <a:t>P=0.15</a:t>
              </a: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4721093" y="671900"/>
            <a:ext cx="1960795" cy="4309968"/>
            <a:chOff x="4992125" y="1163906"/>
            <a:chExt cx="1960795" cy="4309968"/>
          </a:xfrm>
        </p:grpSpPr>
        <p:pic>
          <p:nvPicPr>
            <p:cNvPr id="17" name="Picture 4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4525" y="1444151"/>
              <a:ext cx="1808395" cy="18882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5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92125" y="3526936"/>
              <a:ext cx="1960795" cy="19469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9" name="TextBox 18"/>
            <p:cNvSpPr txBox="1"/>
            <p:nvPr/>
          </p:nvSpPr>
          <p:spPr>
            <a:xfrm>
              <a:off x="5757432" y="1163906"/>
              <a:ext cx="8700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RAB27A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638800" y="2078994"/>
              <a:ext cx="8264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/>
                <a:t>P=0.33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019800" y="3940804"/>
              <a:ext cx="8909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AUC: 0.53</a:t>
              </a:r>
            </a:p>
            <a:p>
              <a:r>
                <a:rPr lang="en-US" sz="1000" b="1" dirty="0"/>
                <a:t>P=0.18</a:t>
              </a:r>
            </a:p>
          </p:txBody>
        </p:sp>
      </p:grpSp>
      <p:pic>
        <p:nvPicPr>
          <p:cNvPr id="23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64" b="6730"/>
          <a:stretch/>
        </p:blipFill>
        <p:spPr bwMode="auto">
          <a:xfrm>
            <a:off x="221369" y="5414675"/>
            <a:ext cx="2000131" cy="1751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7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73" b="6718"/>
          <a:stretch/>
        </p:blipFill>
        <p:spPr bwMode="auto">
          <a:xfrm>
            <a:off x="2178335" y="5411326"/>
            <a:ext cx="1990648" cy="17547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TextBox 24"/>
          <p:cNvSpPr txBox="1"/>
          <p:nvPr/>
        </p:nvSpPr>
        <p:spPr>
          <a:xfrm>
            <a:off x="1218525" y="5196644"/>
            <a:ext cx="19818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Drug transport protein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72362" y="7108042"/>
            <a:ext cx="7160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b="1" dirty="0"/>
              <a:t>MRP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894014" y="7110252"/>
            <a:ext cx="7160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P-</a:t>
            </a:r>
            <a:r>
              <a:rPr lang="en-US" sz="1000" b="1" dirty="0" err="1" smtClean="0"/>
              <a:t>gp</a:t>
            </a:r>
            <a:endParaRPr lang="en-US" sz="1000" b="1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-207495" y="6128400"/>
            <a:ext cx="6416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pGSN</a:t>
            </a:r>
          </a:p>
        </p:txBody>
      </p:sp>
      <p:pic>
        <p:nvPicPr>
          <p:cNvPr id="30" name="Picture 8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2" b="7910"/>
          <a:stretch/>
        </p:blipFill>
        <p:spPr bwMode="auto">
          <a:xfrm>
            <a:off x="4753879" y="5459498"/>
            <a:ext cx="1875521" cy="1722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5275587" y="7105740"/>
            <a:ext cx="826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RAB27A</a:t>
            </a:r>
          </a:p>
        </p:txBody>
      </p:sp>
      <p:sp>
        <p:nvSpPr>
          <p:cNvPr id="32" name="TextBox 31"/>
          <p:cNvSpPr txBox="1"/>
          <p:nvPr/>
        </p:nvSpPr>
        <p:spPr>
          <a:xfrm rot="16200000">
            <a:off x="4231444" y="6024255"/>
            <a:ext cx="826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pGSN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648200" y="5166986"/>
            <a:ext cx="2074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Exosome-associated protein</a:t>
            </a:r>
          </a:p>
        </p:txBody>
      </p:sp>
      <p:sp>
        <p:nvSpPr>
          <p:cNvPr id="34" name="Title 1"/>
          <p:cNvSpPr txBox="1">
            <a:spLocks/>
          </p:cNvSpPr>
          <p:nvPr/>
        </p:nvSpPr>
        <p:spPr>
          <a:xfrm>
            <a:off x="275768" y="74"/>
            <a:ext cx="6172200" cy="47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00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/>
              <a:t>Supp. Fig. 1: OVCA tumor expressions of drug transport proteins and RAB27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-76200" y="7439561"/>
            <a:ext cx="69558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Supp. Fig. 1. Correlation between pGSN and drug transport proteins as well as </a:t>
            </a:r>
            <a:r>
              <a:rPr lang="en-US" sz="1000" b="1" dirty="0" err="1">
                <a:latin typeface="Times New Roman" pitchFamily="18" charset="0"/>
                <a:cs typeface="Times New Roman" pitchFamily="18" charset="0"/>
              </a:rPr>
              <a:t>exosome</a:t>
            </a: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-associated proteins in OVCA patient tumors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. (A) Our interrogation of TCGA public dataset revealed that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but not MRP2 and RAB27A are significantly predictive of chemoresistance in human OVCA tumors. (B) A positive correlation was observed between pGSN and MRP2,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and (C) RAB27A. N=958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-26597" y="533400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-26597" y="5105843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173928" y="5067743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685152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圖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720"/>
          <a:stretch/>
        </p:blipFill>
        <p:spPr>
          <a:xfrm>
            <a:off x="128337" y="3160664"/>
            <a:ext cx="6577263" cy="1251019"/>
          </a:xfrm>
          <a:prstGeom prst="rect">
            <a:avLst/>
          </a:prstGeo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282039" y="159299"/>
            <a:ext cx="6172200" cy="47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00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/>
              <a:t>Supp. Fig. 2: pGSN regulates CDDP and exosome secretion in HGS OVCA cell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173715" y="6631225"/>
            <a:ext cx="2857936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Supp. Fig. 2. pGSN regulates exosomal release in high grade serous (HGS) OVCA cell lines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Human recombinant pGSN was synthesized with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Myc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and 6His tags inserted. The refolded gel UV absorbance measured with A280=0.0210497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pGSN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downregulation in chemoresistant HGS cells reduced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EV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production whereas the vice-versa occurs when pGSN in over-expressed in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chemosensitive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HGS cells. pGSN was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silenced in chemoresistant cells (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siRNA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; 50 nM, 24 h) and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over-expressed in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chemosensitive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cells (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cDNA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; 2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ug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, 24 h)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Small EV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concentrations were determined by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iosensor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EV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aggregation using Raman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spectroscopy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. Results are expressed as means ± SD from three independent replicate experiments. </a:t>
            </a: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505" y="560073"/>
            <a:ext cx="5684645" cy="2766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1846" y="4353709"/>
            <a:ext cx="3223673" cy="22775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圖片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782" t="86468" r="43154"/>
          <a:stretch/>
        </p:blipFill>
        <p:spPr>
          <a:xfrm>
            <a:off x="2952463" y="4411683"/>
            <a:ext cx="925032" cy="247939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-68884" y="457200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3929351" y="4822882"/>
            <a:ext cx="2606870" cy="1764043"/>
            <a:chOff x="-304800" y="1128325"/>
            <a:chExt cx="2606870" cy="1764043"/>
          </a:xfrm>
        </p:grpSpPr>
        <p:pic>
          <p:nvPicPr>
            <p:cNvPr id="28" name="Picture 2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68" t="15232" r="33802" b="19697"/>
            <a:stretch/>
          </p:blipFill>
          <p:spPr bwMode="auto">
            <a:xfrm>
              <a:off x="434994" y="1400175"/>
              <a:ext cx="1768415" cy="1209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" name="Picture 2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3521" b="8240"/>
            <a:stretch/>
          </p:blipFill>
          <p:spPr bwMode="auto">
            <a:xfrm>
              <a:off x="-304800" y="2651181"/>
              <a:ext cx="2432009" cy="2411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0" name="TextBox 29"/>
            <p:cNvSpPr txBox="1"/>
            <p:nvPr/>
          </p:nvSpPr>
          <p:spPr>
            <a:xfrm>
              <a:off x="434994" y="1128325"/>
              <a:ext cx="18670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hemoresistant HGS;</a:t>
              </a:r>
              <a:r>
                <a:rPr kumimoji="0" lang="en-US" sz="900" b="1" i="0" u="none" strike="noStrike" kern="0" cap="none" spc="0" normalizeH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 </a:t>
              </a:r>
              <a:r>
                <a:rPr kumimoji="0" lang="en-US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OV90</a:t>
              </a:r>
              <a:endPara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-68884" y="6833649"/>
            <a:ext cx="4114800" cy="1776951"/>
            <a:chOff x="2590800" y="1128325"/>
            <a:chExt cx="4114800" cy="1776951"/>
          </a:xfrm>
        </p:grpSpPr>
        <p:pic>
          <p:nvPicPr>
            <p:cNvPr id="32" name="Picture 3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30" t="14205" r="35144" b="18944"/>
            <a:stretch/>
          </p:blipFill>
          <p:spPr bwMode="auto">
            <a:xfrm>
              <a:off x="3039374" y="1400175"/>
              <a:ext cx="1828564" cy="12510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3" name="Picture 4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10" t="13394" r="34160" b="19414"/>
            <a:stretch/>
          </p:blipFill>
          <p:spPr bwMode="auto">
            <a:xfrm>
              <a:off x="4953000" y="1400175"/>
              <a:ext cx="1600200" cy="12510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4" name="TextBox 33"/>
            <p:cNvSpPr txBox="1"/>
            <p:nvPr/>
          </p:nvSpPr>
          <p:spPr>
            <a:xfrm>
              <a:off x="3077356" y="1128325"/>
              <a:ext cx="17525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hemosenistive HGS; TOV3133</a:t>
              </a:r>
              <a:endPara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953000" y="1128325"/>
              <a:ext cx="1752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hemosensitive HGS; TOV3041G</a:t>
              </a:r>
              <a:endPara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pic>
          <p:nvPicPr>
            <p:cNvPr id="36" name="Picture 4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67" t="84207" r="8213" b="7897"/>
            <a:stretch/>
          </p:blipFill>
          <p:spPr bwMode="auto">
            <a:xfrm>
              <a:off x="2590800" y="2671751"/>
              <a:ext cx="1981200" cy="233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7" name="Picture 4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295" t="84207" r="8213" b="7897"/>
            <a:stretch/>
          </p:blipFill>
          <p:spPr bwMode="auto">
            <a:xfrm>
              <a:off x="5275555" y="2668367"/>
              <a:ext cx="1039520" cy="233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38" name="TextBox 37"/>
          <p:cNvSpPr txBox="1"/>
          <p:nvPr/>
        </p:nvSpPr>
        <p:spPr>
          <a:xfrm rot="16200000">
            <a:off x="4075185" y="5473098"/>
            <a:ext cx="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V (nM)</a:t>
            </a:r>
          </a:p>
        </p:txBody>
      </p:sp>
      <p:sp>
        <p:nvSpPr>
          <p:cNvPr id="39" name="TextBox 38"/>
          <p:cNvSpPr txBox="1"/>
          <p:nvPr/>
        </p:nvSpPr>
        <p:spPr>
          <a:xfrm rot="16200000">
            <a:off x="-245482" y="7483866"/>
            <a:ext cx="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V (nM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151560" y="4822882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B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-108412" y="6833649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C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8872741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-67826" y="1156156"/>
            <a:ext cx="2395240" cy="1803493"/>
            <a:chOff x="-168615" y="6261556"/>
            <a:chExt cx="2395240" cy="1803493"/>
          </a:xfrm>
        </p:grpSpPr>
        <p:pic>
          <p:nvPicPr>
            <p:cNvPr id="7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46" t="20203" r="15311" b="15455"/>
            <a:stretch/>
          </p:blipFill>
          <p:spPr bwMode="auto">
            <a:xfrm>
              <a:off x="469077" y="6308334"/>
              <a:ext cx="1757548" cy="12647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 rot="16200000">
              <a:off x="-359895" y="6850306"/>
              <a:ext cx="8829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Rate (</a:t>
              </a:r>
              <a:r>
                <a:rPr kumimoji="0" lang="en-US" sz="900" b="1" i="0" u="none" strike="noStrike" kern="0" cap="none" spc="0" normalizeH="0" baseline="0" noProof="0" dirty="0" err="1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ts</a:t>
              </a:r>
              <a:r>
                <a:rPr kumimoji="0" lang="en-US" sz="9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/min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44321" y="7404556"/>
              <a:ext cx="3652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0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68121" y="6858000"/>
              <a:ext cx="3652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15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12703" y="6261556"/>
              <a:ext cx="4968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30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-168615" y="7584315"/>
              <a:ext cx="73123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Buffer A</a:t>
              </a: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800" b="1" kern="0" dirty="0">
                  <a:solidFill>
                    <a:sysClr val="windowText" lastClr="000000"/>
                  </a:solidFill>
                </a:rPr>
                <a:t>Buffer B</a:t>
              </a: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DDP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477383" y="7665698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923465" y="7687643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48642" y="7776459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021195" y="7543800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17271" y="7776459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470068" y="7788050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922851" y="7788050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+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74853" y="7548529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483479" y="7562705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940703" y="7559541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70586" y="7634306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032053" y="7657039"/>
              <a:ext cx="263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-</a:t>
              </a:r>
            </a:p>
          </p:txBody>
        </p:sp>
      </p:grpSp>
      <p:pic>
        <p:nvPicPr>
          <p:cNvPr id="26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70" t="10047" r="14019" b="15118"/>
          <a:stretch/>
        </p:blipFill>
        <p:spPr bwMode="auto">
          <a:xfrm>
            <a:off x="2693822" y="1202934"/>
            <a:ext cx="1905000" cy="15313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2693822" y="2673195"/>
            <a:ext cx="3652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40</a:t>
            </a: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4278649" y="2682901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1600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440448" y="2671059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1000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1929856" y="1827174"/>
            <a:ext cx="1297099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Raman Intensity (AU)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210150" y="2805905"/>
            <a:ext cx="1297099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Raman Shift</a:t>
            </a:r>
            <a:r>
              <a:rPr kumimoji="0" lang="en-US" sz="900" b="1" i="0" u="none" strike="noStrike" kern="0" cap="none" spc="0" normalizeH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 (cm</a:t>
            </a:r>
            <a:r>
              <a:rPr kumimoji="0" lang="en-US" sz="900" b="1" i="0" u="none" strike="noStrike" kern="0" cap="none" spc="0" normalizeH="0" noProof="0" dirty="0">
                <a:ln>
                  <a:noFill/>
                </a:ln>
                <a:solidFill>
                  <a:sysClr val="windowText" lastClr="000000"/>
                </a:solidFill>
                <a:uLnTx/>
                <a:uFillTx/>
              </a:rPr>
              <a:t>-1</a:t>
            </a:r>
            <a:r>
              <a:rPr kumimoji="0" lang="en-US" sz="900" b="1" i="0" u="none" strike="noStrike" kern="0" cap="none" spc="0" normalizeH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)</a:t>
            </a:r>
            <a:endParaRPr kumimoji="0" lang="en-US" sz="9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47" t="9945" r="12101" b="16593"/>
          <a:stretch/>
        </p:blipFill>
        <p:spPr bwMode="auto">
          <a:xfrm>
            <a:off x="4953000" y="1202934"/>
            <a:ext cx="1905000" cy="14962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TextBox 32"/>
          <p:cNvSpPr txBox="1"/>
          <p:nvPr/>
        </p:nvSpPr>
        <p:spPr>
          <a:xfrm>
            <a:off x="5179901" y="2817167"/>
            <a:ext cx="15256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ctual concentration (%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876800" y="2667258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0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477000" y="2680156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100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676900" y="2667000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50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3924567" y="1878643"/>
            <a:ext cx="15256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Predicted concentration (%)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688065" y="2461553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0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688065" y="1913208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50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648200" y="1263878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kern="0" dirty="0">
                <a:solidFill>
                  <a:sysClr val="windowText" lastClr="000000"/>
                </a:solidFill>
              </a:rPr>
              <a:t>100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41" name="Title 1"/>
          <p:cNvSpPr txBox="1">
            <a:spLocks/>
          </p:cNvSpPr>
          <p:nvPr/>
        </p:nvSpPr>
        <p:spPr>
          <a:xfrm>
            <a:off x="81584" y="159299"/>
            <a:ext cx="6471616" cy="47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75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/>
              <a:t>Supp. Fig. 3: </a:t>
            </a:r>
            <a:r>
              <a:rPr lang="en-US" sz="2000" b="1" dirty="0" smtClean="0"/>
              <a:t>Validation of biosensor on human OVCA plasma-derived EVs</a:t>
            </a:r>
            <a:endParaRPr lang="en-US" sz="20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66957" y="3047999"/>
            <a:ext cx="673943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Supp. Fig. 3. Plasma-derived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mall EV </a:t>
            </a: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isolation, characterization and biosensor detection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Biosensor detection of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small EVs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and CDDP were performed using buffer A and B from the Exoquick Ultra kit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Raman peaks of Buffer A and B were generated to determine their composition and potential influence on exosome and CDDP detection. 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0" y="762000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293316" y="762000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B</a:t>
            </a:r>
            <a:endParaRPr kumimoji="0" lang="en-US" sz="12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12531200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extLst mod="1">
    <p:ext uri="{6950BFC3-D8DA-4A85-94F7-54DA5524770B}">
      <p188:commentRel xmlns="" xmlns:p188="http://schemas.microsoft.com/office/powerpoint/2018/8/main" r:id="rId7"/>
    </p:ext>
  </p:extLs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84"/>
          <a:stretch/>
        </p:blipFill>
        <p:spPr bwMode="auto">
          <a:xfrm>
            <a:off x="318600" y="1066800"/>
            <a:ext cx="1800879" cy="16217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99"/>
          <a:stretch/>
        </p:blipFill>
        <p:spPr bwMode="auto">
          <a:xfrm>
            <a:off x="2682815" y="1066801"/>
            <a:ext cx="1829027" cy="16217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76"/>
          <a:stretch/>
        </p:blipFill>
        <p:spPr bwMode="auto">
          <a:xfrm>
            <a:off x="2760452" y="2819400"/>
            <a:ext cx="1842161" cy="16217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85"/>
          <a:stretch/>
        </p:blipFill>
        <p:spPr bwMode="auto">
          <a:xfrm>
            <a:off x="431109" y="2819400"/>
            <a:ext cx="1866450" cy="1441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51"/>
          <a:stretch/>
        </p:blipFill>
        <p:spPr bwMode="auto">
          <a:xfrm>
            <a:off x="5020574" y="1066800"/>
            <a:ext cx="1837426" cy="1523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62"/>
          <a:stretch/>
        </p:blipFill>
        <p:spPr bwMode="auto">
          <a:xfrm>
            <a:off x="5020574" y="2819399"/>
            <a:ext cx="1889653" cy="16217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51"/>
          <a:stretch/>
        </p:blipFill>
        <p:spPr bwMode="auto">
          <a:xfrm>
            <a:off x="431109" y="4848999"/>
            <a:ext cx="1695680" cy="16280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4848999"/>
            <a:ext cx="2088014" cy="17306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4791061"/>
            <a:ext cx="2133600" cy="17621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itle 1"/>
          <p:cNvSpPr txBox="1">
            <a:spLocks/>
          </p:cNvSpPr>
          <p:nvPr/>
        </p:nvSpPr>
        <p:spPr>
          <a:xfrm>
            <a:off x="318600" y="81777"/>
            <a:ext cx="6172200" cy="47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00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/>
              <a:t>Supp. Fig. 4: Prognostic significance of exosome and Ex/CA125 in OVCA patient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085809" y="6961935"/>
            <a:ext cx="47244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Supp. Fig. 4. Prognostic significance of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sEVs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sEVs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/CA125 </a:t>
            </a: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in OVCA outcomes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Small EVs were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isolated from the plasma of human OVCA patient with pre-determined CA125. (A) Mean ± SD of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EV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or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EV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/CA125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were determined and compared within clinical outcomes (diagnosis, residual disease, chemoresistance, stage, tumor recurrence and CA125 levels). (B) Plasma-derived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EV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were correlated with CA125 in malignant OVCA patients. (C) The mean ± SD levels of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EV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/CA125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were determined and compared within OVCA clinical outcomes (residual disease and histological subtype). 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-94975" y="789801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-94975" y="4572000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297559" y="4572000"/>
            <a:ext cx="52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-202689" y="1575999"/>
            <a:ext cx="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V (</a:t>
            </a:r>
            <a:r>
              <a:rPr lang="en-US" sz="1200" b="1" dirty="0" err="1"/>
              <a:t>nM</a:t>
            </a:r>
            <a:r>
              <a:rPr lang="en-US" sz="1200" b="1" dirty="0"/>
              <a:t>)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-204399" y="3199236"/>
            <a:ext cx="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V (</a:t>
            </a:r>
            <a:r>
              <a:rPr lang="en-US" sz="1200" b="1" dirty="0" err="1"/>
              <a:t>nM</a:t>
            </a:r>
            <a:r>
              <a:rPr lang="en-US" sz="1200" b="1" dirty="0"/>
              <a:t>)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073880" y="1575999"/>
            <a:ext cx="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V (</a:t>
            </a:r>
            <a:r>
              <a:rPr lang="en-US" sz="1200" b="1" dirty="0" err="1"/>
              <a:t>nM</a:t>
            </a:r>
            <a:r>
              <a:rPr lang="en-US" sz="1200" b="1" dirty="0"/>
              <a:t>)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2157800" y="3239992"/>
            <a:ext cx="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V (</a:t>
            </a:r>
            <a:r>
              <a:rPr lang="en-US" sz="1200" b="1" dirty="0" err="1"/>
              <a:t>nM</a:t>
            </a:r>
            <a:r>
              <a:rPr lang="en-US" sz="1200" b="1" dirty="0"/>
              <a:t>)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4386776" y="1576000"/>
            <a:ext cx="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V (</a:t>
            </a:r>
            <a:r>
              <a:rPr lang="en-US" sz="1200" b="1" dirty="0" err="1"/>
              <a:t>nM</a:t>
            </a:r>
            <a:r>
              <a:rPr lang="en-US" sz="1200" b="1" dirty="0"/>
              <a:t>)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4386775" y="3268345"/>
            <a:ext cx="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V (</a:t>
            </a:r>
            <a:r>
              <a:rPr lang="en-US" sz="1200" b="1" dirty="0" err="1"/>
              <a:t>nM</a:t>
            </a:r>
            <a:r>
              <a:rPr lang="en-US" sz="1200" b="1" dirty="0"/>
              <a:t>)</a:t>
            </a:r>
          </a:p>
        </p:txBody>
      </p:sp>
      <p:sp>
        <p:nvSpPr>
          <p:cNvPr id="23" name="TextBox 22"/>
          <p:cNvSpPr txBox="1"/>
          <p:nvPr/>
        </p:nvSpPr>
        <p:spPr>
          <a:xfrm rot="16200000">
            <a:off x="-176700" y="5309799"/>
            <a:ext cx="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EV (</a:t>
            </a:r>
            <a:r>
              <a:rPr lang="en-US" sz="1200" b="1" dirty="0" err="1"/>
              <a:t>nM</a:t>
            </a:r>
            <a:r>
              <a:rPr lang="en-US" sz="1200" b="1" dirty="0"/>
              <a:t>)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04001" y="6594613"/>
            <a:ext cx="1916460" cy="1558787"/>
            <a:chOff x="104001" y="6477000"/>
            <a:chExt cx="1916460" cy="1558787"/>
          </a:xfrm>
        </p:grpSpPr>
        <p:pic>
          <p:nvPicPr>
            <p:cNvPr id="1034" name="Picture 10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11" t="10965"/>
            <a:stretch/>
          </p:blipFill>
          <p:spPr bwMode="auto">
            <a:xfrm>
              <a:off x="320963" y="6664028"/>
              <a:ext cx="1699498" cy="137175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4" name="TextBox 23"/>
            <p:cNvSpPr txBox="1"/>
            <p:nvPr/>
          </p:nvSpPr>
          <p:spPr>
            <a:xfrm rot="16200000">
              <a:off x="-178832" y="7475955"/>
              <a:ext cx="8426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sEV (</a:t>
              </a:r>
              <a:r>
                <a:rPr lang="en-US" sz="1200" b="1" dirty="0" err="1"/>
                <a:t>nM</a:t>
              </a:r>
              <a:r>
                <a:rPr lang="en-US" sz="1200" b="1" dirty="0"/>
                <a:t>)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-36936" y="6823436"/>
              <a:ext cx="609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CA125</a:t>
              </a:r>
              <a:endParaRPr lang="en-US" sz="12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838200" y="6477000"/>
              <a:ext cx="8426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sEV (</a:t>
              </a:r>
              <a:r>
                <a:rPr lang="en-US" sz="1200" b="1" dirty="0" err="1"/>
                <a:t>nM</a:t>
              </a:r>
              <a:r>
                <a:rPr lang="en-US" sz="1200" b="1" dirty="0"/>
                <a:t>)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04800" y="6477000"/>
              <a:ext cx="609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CA125</a:t>
              </a:r>
              <a:endParaRPr 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569355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52</TotalTime>
  <Words>571</Words>
  <Application>Microsoft Office PowerPoint</Application>
  <PresentationFormat>On-screen Show (4:3)</PresentationFormat>
  <Paragraphs>8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The Ottawa Hospit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are-Werehene, Meshach</dc:creator>
  <cp:lastModifiedBy>Asare-Werehene, Meshach</cp:lastModifiedBy>
  <cp:revision>41</cp:revision>
  <dcterms:created xsi:type="dcterms:W3CDTF">2022-05-30T20:26:53Z</dcterms:created>
  <dcterms:modified xsi:type="dcterms:W3CDTF">2022-10-14T18:32:25Z</dcterms:modified>
</cp:coreProperties>
</file>